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3" d="100"/>
          <a:sy n="43" d="100"/>
        </p:scale>
        <p:origin x="1445" y="53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ZZX\diatom_paper\CE\BAWW\BAWW_non_pin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6.8603349421167498E-2"/>
          <c:y val="5.1400554097404495E-2"/>
          <c:w val="0.93139665057883325"/>
          <c:h val="0.62098602984406082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1!$B$95</c:f>
              <c:strCache>
                <c:ptCount val="1"/>
                <c:pt idx="0">
                  <c:v>BA(-2/-1) content (%)</c:v>
                </c:pt>
              </c:strCache>
            </c:strRef>
          </c:tx>
          <c:invertIfNegative val="0"/>
          <c:cat>
            <c:strRef>
              <c:f>Sheet1!$A$96:$A$102</c:f>
              <c:strCache>
                <c:ptCount val="7"/>
                <c:pt idx="0">
                  <c:v>ciliate</c:v>
                </c:pt>
                <c:pt idx="1">
                  <c:v>diatom_t</c:v>
                </c:pt>
                <c:pt idx="2">
                  <c:v>diatom_p</c:v>
                </c:pt>
                <c:pt idx="3">
                  <c:v>red alga</c:v>
                </c:pt>
                <c:pt idx="4">
                  <c:v>Ostreococcus</c:v>
                </c:pt>
                <c:pt idx="5">
                  <c:v>moss</c:v>
                </c:pt>
                <c:pt idx="6">
                  <c:v>spikemoss</c:v>
                </c:pt>
              </c:strCache>
            </c:strRef>
          </c:cat>
          <c:val>
            <c:numRef>
              <c:f>Sheet1!$B$96:$B$102</c:f>
              <c:numCache>
                <c:formatCode>General</c:formatCode>
                <c:ptCount val="7"/>
                <c:pt idx="0">
                  <c:v>83.84</c:v>
                </c:pt>
                <c:pt idx="1">
                  <c:v>63.71</c:v>
                </c:pt>
                <c:pt idx="2">
                  <c:v>70.23</c:v>
                </c:pt>
                <c:pt idx="3">
                  <c:v>75.48</c:v>
                </c:pt>
                <c:pt idx="4">
                  <c:v>59.9</c:v>
                </c:pt>
                <c:pt idx="5">
                  <c:v>76.11</c:v>
                </c:pt>
                <c:pt idx="6">
                  <c:v>63.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14B-43BE-8770-0C4CF28D5B37}"/>
            </c:ext>
          </c:extLst>
        </c:ser>
        <c:ser>
          <c:idx val="1"/>
          <c:order val="1"/>
          <c:tx>
            <c:strRef>
              <c:f>Sheet1!$C$95</c:f>
              <c:strCache>
                <c:ptCount val="1"/>
                <c:pt idx="0">
                  <c:v>YA(-2/-1) content (%)</c:v>
                </c:pt>
              </c:strCache>
            </c:strRef>
          </c:tx>
          <c:invertIfNegative val="0"/>
          <c:cat>
            <c:strRef>
              <c:f>Sheet1!$A$96:$A$102</c:f>
              <c:strCache>
                <c:ptCount val="7"/>
                <c:pt idx="0">
                  <c:v>ciliate</c:v>
                </c:pt>
                <c:pt idx="1">
                  <c:v>diatom_t</c:v>
                </c:pt>
                <c:pt idx="2">
                  <c:v>diatom_p</c:v>
                </c:pt>
                <c:pt idx="3">
                  <c:v>red alga</c:v>
                </c:pt>
                <c:pt idx="4">
                  <c:v>Ostreococcus</c:v>
                </c:pt>
                <c:pt idx="5">
                  <c:v>moss</c:v>
                </c:pt>
                <c:pt idx="6">
                  <c:v>spikemoss</c:v>
                </c:pt>
              </c:strCache>
            </c:strRef>
          </c:cat>
          <c:val>
            <c:numRef>
              <c:f>Sheet1!$C$96:$C$102</c:f>
              <c:numCache>
                <c:formatCode>General</c:formatCode>
                <c:ptCount val="7"/>
                <c:pt idx="0">
                  <c:v>79.7</c:v>
                </c:pt>
                <c:pt idx="1">
                  <c:v>43.83</c:v>
                </c:pt>
                <c:pt idx="2">
                  <c:v>49.94</c:v>
                </c:pt>
                <c:pt idx="3">
                  <c:v>46.45</c:v>
                </c:pt>
                <c:pt idx="4">
                  <c:v>46.1</c:v>
                </c:pt>
                <c:pt idx="5">
                  <c:v>59.32</c:v>
                </c:pt>
                <c:pt idx="6">
                  <c:v>49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14B-43BE-8770-0C4CF28D5B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4253440"/>
        <c:axId val="54254976"/>
        <c:axId val="0"/>
      </c:bar3DChart>
      <c:catAx>
        <c:axId val="542534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54254976"/>
        <c:crosses val="autoZero"/>
        <c:auto val="1"/>
        <c:lblAlgn val="ctr"/>
        <c:lblOffset val="100"/>
        <c:noMultiLvlLbl val="0"/>
      </c:catAx>
      <c:valAx>
        <c:axId val="5425497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542534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6.0846456692912809E-3"/>
          <c:y val="0.91169326518464799"/>
          <c:w val="0.99391535433070899"/>
          <c:h val="7.4801560976559836E-2"/>
        </c:manualLayout>
      </c:layout>
      <c:overlay val="0"/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97783" y="764126"/>
            <a:ext cx="430887" cy="273630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Dinucleotide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frequency (%)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Picture 2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4016" y="3996383"/>
            <a:ext cx="3430800" cy="403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456384" y="3995936"/>
            <a:ext cx="3429000" cy="40324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10" name="Chart 9"/>
          <p:cNvGraphicFramePr/>
          <p:nvPr/>
        </p:nvGraphicFramePr>
        <p:xfrm>
          <a:off x="785794" y="1142976"/>
          <a:ext cx="5643602" cy="32861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548681" y="7884368"/>
            <a:ext cx="61926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/>
              <a:t>Figure </a:t>
            </a:r>
            <a:r>
              <a:rPr lang="en-US" b="1" smtClean="0"/>
              <a:t>S4</a:t>
            </a:r>
            <a:r>
              <a:rPr lang="en-US" b="1" dirty="0" smtClean="0"/>
              <a:t>. </a:t>
            </a:r>
            <a:r>
              <a:rPr lang="en-US" b="1" dirty="0"/>
              <a:t>The </a:t>
            </a:r>
            <a:r>
              <a:rPr lang="en-US" b="1" dirty="0" smtClean="0"/>
              <a:t>conserved </a:t>
            </a:r>
            <a:r>
              <a:rPr lang="en-US" b="1" dirty="0"/>
              <a:t>structures in CE region in the 7 species. </a:t>
            </a:r>
            <a:r>
              <a:rPr lang="en-US" b="1" dirty="0" smtClean="0"/>
              <a:t> The box-plot represent the collective rang of the BA (right) and YA (left) elements. 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3</TotalTime>
  <Words>3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alter</dc:creator>
  <cp:lastModifiedBy>MDPI</cp:lastModifiedBy>
  <cp:revision>56</cp:revision>
  <cp:lastPrinted>2013-08-22T01:06:28Z</cp:lastPrinted>
  <dcterms:created xsi:type="dcterms:W3CDTF">2010-03-29T21:15:18Z</dcterms:created>
  <dcterms:modified xsi:type="dcterms:W3CDTF">2019-02-21T02:37:15Z</dcterms:modified>
</cp:coreProperties>
</file>